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083300" cy="953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625"/>
  </p:normalViewPr>
  <p:slideViewPr>
    <p:cSldViewPr snapToGrid="0">
      <p:cViewPr varScale="1">
        <p:scale>
          <a:sx n="76" d="100"/>
          <a:sy n="76" d="100"/>
        </p:scale>
        <p:origin x="27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6253" y="1561176"/>
            <a:ext cx="5170805" cy="3321086"/>
          </a:xfrm>
        </p:spPr>
        <p:txBody>
          <a:bodyPr anchor="b"/>
          <a:lstStyle>
            <a:lvl1pPr algn="ctr">
              <a:defRPr sz="406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0418" y="5010335"/>
            <a:ext cx="4562475" cy="2303119"/>
          </a:xfrm>
        </p:spPr>
        <p:txBody>
          <a:bodyPr/>
          <a:lstStyle>
            <a:lvl1pPr marL="0" indent="0" algn="ctr">
              <a:buNone/>
              <a:defRPr sz="1628"/>
            </a:lvl1pPr>
            <a:lvl2pPr marL="310013" indent="0" algn="ctr">
              <a:buNone/>
              <a:defRPr sz="1357"/>
            </a:lvl2pPr>
            <a:lvl3pPr marL="620027" indent="0" algn="ctr">
              <a:buNone/>
              <a:defRPr sz="1221"/>
            </a:lvl3pPr>
            <a:lvl4pPr marL="930039" indent="0" algn="ctr">
              <a:buNone/>
              <a:defRPr sz="1084"/>
            </a:lvl4pPr>
            <a:lvl5pPr marL="1240055" indent="0" algn="ctr">
              <a:buNone/>
              <a:defRPr sz="1084"/>
            </a:lvl5pPr>
            <a:lvl6pPr marL="1550068" indent="0" algn="ctr">
              <a:buNone/>
              <a:defRPr sz="1084"/>
            </a:lvl6pPr>
            <a:lvl7pPr marL="1860082" indent="0" algn="ctr">
              <a:buNone/>
              <a:defRPr sz="1084"/>
            </a:lvl7pPr>
            <a:lvl8pPr marL="2170095" indent="0" algn="ctr">
              <a:buNone/>
              <a:defRPr sz="1084"/>
            </a:lvl8pPr>
            <a:lvl9pPr marL="2480109" indent="0" algn="ctr">
              <a:buNone/>
              <a:defRPr sz="108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0734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789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53362" y="507880"/>
            <a:ext cx="1311712" cy="80841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18232" y="507880"/>
            <a:ext cx="3859093" cy="80841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827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713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5059" y="2378200"/>
            <a:ext cx="5246846" cy="3968078"/>
          </a:xfrm>
        </p:spPr>
        <p:txBody>
          <a:bodyPr anchor="b"/>
          <a:lstStyle>
            <a:lvl1pPr>
              <a:defRPr sz="406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5059" y="6383819"/>
            <a:ext cx="5246846" cy="2086718"/>
          </a:xfrm>
        </p:spPr>
        <p:txBody>
          <a:bodyPr/>
          <a:lstStyle>
            <a:lvl1pPr marL="0" indent="0">
              <a:buNone/>
              <a:defRPr sz="1628">
                <a:solidFill>
                  <a:schemeClr val="tx1">
                    <a:tint val="82000"/>
                  </a:schemeClr>
                </a:solidFill>
              </a:defRPr>
            </a:lvl1pPr>
            <a:lvl2pPr marL="310013" indent="0">
              <a:buNone/>
              <a:defRPr sz="1357">
                <a:solidFill>
                  <a:schemeClr val="tx1">
                    <a:tint val="82000"/>
                  </a:schemeClr>
                </a:solidFill>
              </a:defRPr>
            </a:lvl2pPr>
            <a:lvl3pPr marL="620027" indent="0">
              <a:buNone/>
              <a:defRPr sz="1221">
                <a:solidFill>
                  <a:schemeClr val="tx1">
                    <a:tint val="82000"/>
                  </a:schemeClr>
                </a:solidFill>
              </a:defRPr>
            </a:lvl3pPr>
            <a:lvl4pPr marL="930039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4pPr>
            <a:lvl5pPr marL="1240055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5pPr>
            <a:lvl6pPr marL="1550068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6pPr>
            <a:lvl7pPr marL="1860082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7pPr>
            <a:lvl8pPr marL="2170095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8pPr>
            <a:lvl9pPr marL="2480109" indent="0">
              <a:buNone/>
              <a:defRPr sz="108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5008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8228" y="2539394"/>
            <a:ext cx="2585403" cy="60525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79675" y="2539394"/>
            <a:ext cx="2585403" cy="60525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4636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9019" y="507882"/>
            <a:ext cx="5246846" cy="18438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9024" y="2338452"/>
            <a:ext cx="2573521" cy="1146038"/>
          </a:xfrm>
        </p:spPr>
        <p:txBody>
          <a:bodyPr anchor="b"/>
          <a:lstStyle>
            <a:lvl1pPr marL="0" indent="0">
              <a:buNone/>
              <a:defRPr sz="1628" b="1"/>
            </a:lvl1pPr>
            <a:lvl2pPr marL="310013" indent="0">
              <a:buNone/>
              <a:defRPr sz="1357" b="1"/>
            </a:lvl2pPr>
            <a:lvl3pPr marL="620027" indent="0">
              <a:buNone/>
              <a:defRPr sz="1221" b="1"/>
            </a:lvl3pPr>
            <a:lvl4pPr marL="930039" indent="0">
              <a:buNone/>
              <a:defRPr sz="1084" b="1"/>
            </a:lvl4pPr>
            <a:lvl5pPr marL="1240055" indent="0">
              <a:buNone/>
              <a:defRPr sz="1084" b="1"/>
            </a:lvl5pPr>
            <a:lvl6pPr marL="1550068" indent="0">
              <a:buNone/>
              <a:defRPr sz="1084" b="1"/>
            </a:lvl6pPr>
            <a:lvl7pPr marL="1860082" indent="0">
              <a:buNone/>
              <a:defRPr sz="1084" b="1"/>
            </a:lvl7pPr>
            <a:lvl8pPr marL="2170095" indent="0">
              <a:buNone/>
              <a:defRPr sz="1084" b="1"/>
            </a:lvl8pPr>
            <a:lvl9pPr marL="2480109" indent="0">
              <a:buNone/>
              <a:defRPr sz="108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024" y="3484492"/>
            <a:ext cx="2573521" cy="5125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79676" y="2338452"/>
            <a:ext cx="2586195" cy="1146038"/>
          </a:xfrm>
        </p:spPr>
        <p:txBody>
          <a:bodyPr anchor="b"/>
          <a:lstStyle>
            <a:lvl1pPr marL="0" indent="0">
              <a:buNone/>
              <a:defRPr sz="1628" b="1"/>
            </a:lvl1pPr>
            <a:lvl2pPr marL="310013" indent="0">
              <a:buNone/>
              <a:defRPr sz="1357" b="1"/>
            </a:lvl2pPr>
            <a:lvl3pPr marL="620027" indent="0">
              <a:buNone/>
              <a:defRPr sz="1221" b="1"/>
            </a:lvl3pPr>
            <a:lvl4pPr marL="930039" indent="0">
              <a:buNone/>
              <a:defRPr sz="1084" b="1"/>
            </a:lvl4pPr>
            <a:lvl5pPr marL="1240055" indent="0">
              <a:buNone/>
              <a:defRPr sz="1084" b="1"/>
            </a:lvl5pPr>
            <a:lvl6pPr marL="1550068" indent="0">
              <a:buNone/>
              <a:defRPr sz="1084" b="1"/>
            </a:lvl6pPr>
            <a:lvl7pPr marL="1860082" indent="0">
              <a:buNone/>
              <a:defRPr sz="1084" b="1"/>
            </a:lvl7pPr>
            <a:lvl8pPr marL="2170095" indent="0">
              <a:buNone/>
              <a:defRPr sz="1084" b="1"/>
            </a:lvl8pPr>
            <a:lvl9pPr marL="2480109" indent="0">
              <a:buNone/>
              <a:defRPr sz="108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79676" y="3484492"/>
            <a:ext cx="2586195" cy="5125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6896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4373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4720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9024" y="635954"/>
            <a:ext cx="1962023" cy="2225834"/>
          </a:xfrm>
        </p:spPr>
        <p:txBody>
          <a:bodyPr anchor="b"/>
          <a:lstStyle>
            <a:lvl1pPr>
              <a:defRPr sz="21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86200" y="1373485"/>
            <a:ext cx="3079671" cy="6779077"/>
          </a:xfrm>
        </p:spPr>
        <p:txBody>
          <a:bodyPr/>
          <a:lstStyle>
            <a:lvl1pPr>
              <a:defRPr sz="2170"/>
            </a:lvl1pPr>
            <a:lvl2pPr>
              <a:defRPr sz="1899"/>
            </a:lvl2pPr>
            <a:lvl3pPr>
              <a:defRPr sz="1628"/>
            </a:lvl3pPr>
            <a:lvl4pPr>
              <a:defRPr sz="1357"/>
            </a:lvl4pPr>
            <a:lvl5pPr>
              <a:defRPr sz="1357"/>
            </a:lvl5pPr>
            <a:lvl6pPr>
              <a:defRPr sz="1357"/>
            </a:lvl6pPr>
            <a:lvl7pPr>
              <a:defRPr sz="1357"/>
            </a:lvl7pPr>
            <a:lvl8pPr>
              <a:defRPr sz="1357"/>
            </a:lvl8pPr>
            <a:lvl9pPr>
              <a:defRPr sz="135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9024" y="2861789"/>
            <a:ext cx="1962023" cy="5301813"/>
          </a:xfrm>
        </p:spPr>
        <p:txBody>
          <a:bodyPr/>
          <a:lstStyle>
            <a:lvl1pPr marL="0" indent="0">
              <a:buNone/>
              <a:defRPr sz="1084"/>
            </a:lvl1pPr>
            <a:lvl2pPr marL="310013" indent="0">
              <a:buNone/>
              <a:defRPr sz="949"/>
            </a:lvl2pPr>
            <a:lvl3pPr marL="620027" indent="0">
              <a:buNone/>
              <a:defRPr sz="813"/>
            </a:lvl3pPr>
            <a:lvl4pPr marL="930039" indent="0">
              <a:buNone/>
              <a:defRPr sz="678"/>
            </a:lvl4pPr>
            <a:lvl5pPr marL="1240055" indent="0">
              <a:buNone/>
              <a:defRPr sz="678"/>
            </a:lvl5pPr>
            <a:lvl6pPr marL="1550068" indent="0">
              <a:buNone/>
              <a:defRPr sz="678"/>
            </a:lvl6pPr>
            <a:lvl7pPr marL="1860082" indent="0">
              <a:buNone/>
              <a:defRPr sz="678"/>
            </a:lvl7pPr>
            <a:lvl8pPr marL="2170095" indent="0">
              <a:buNone/>
              <a:defRPr sz="678"/>
            </a:lvl8pPr>
            <a:lvl9pPr marL="2480109" indent="0">
              <a:buNone/>
              <a:defRPr sz="6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5466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9024" y="635954"/>
            <a:ext cx="1962023" cy="2225834"/>
          </a:xfrm>
        </p:spPr>
        <p:txBody>
          <a:bodyPr anchor="b"/>
          <a:lstStyle>
            <a:lvl1pPr>
              <a:defRPr sz="21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86200" y="1373485"/>
            <a:ext cx="3079671" cy="6779077"/>
          </a:xfrm>
        </p:spPr>
        <p:txBody>
          <a:bodyPr anchor="t"/>
          <a:lstStyle>
            <a:lvl1pPr marL="0" indent="0">
              <a:buNone/>
              <a:defRPr sz="2170"/>
            </a:lvl1pPr>
            <a:lvl2pPr marL="310013" indent="0">
              <a:buNone/>
              <a:defRPr sz="1899"/>
            </a:lvl2pPr>
            <a:lvl3pPr marL="620027" indent="0">
              <a:buNone/>
              <a:defRPr sz="1628"/>
            </a:lvl3pPr>
            <a:lvl4pPr marL="930039" indent="0">
              <a:buNone/>
              <a:defRPr sz="1357"/>
            </a:lvl4pPr>
            <a:lvl5pPr marL="1240055" indent="0">
              <a:buNone/>
              <a:defRPr sz="1357"/>
            </a:lvl5pPr>
            <a:lvl6pPr marL="1550068" indent="0">
              <a:buNone/>
              <a:defRPr sz="1357"/>
            </a:lvl6pPr>
            <a:lvl7pPr marL="1860082" indent="0">
              <a:buNone/>
              <a:defRPr sz="1357"/>
            </a:lvl7pPr>
            <a:lvl8pPr marL="2170095" indent="0">
              <a:buNone/>
              <a:defRPr sz="1357"/>
            </a:lvl8pPr>
            <a:lvl9pPr marL="2480109" indent="0">
              <a:buNone/>
              <a:defRPr sz="135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9024" y="2861789"/>
            <a:ext cx="1962023" cy="5301813"/>
          </a:xfrm>
        </p:spPr>
        <p:txBody>
          <a:bodyPr/>
          <a:lstStyle>
            <a:lvl1pPr marL="0" indent="0">
              <a:buNone/>
              <a:defRPr sz="1084"/>
            </a:lvl1pPr>
            <a:lvl2pPr marL="310013" indent="0">
              <a:buNone/>
              <a:defRPr sz="949"/>
            </a:lvl2pPr>
            <a:lvl3pPr marL="620027" indent="0">
              <a:buNone/>
              <a:defRPr sz="813"/>
            </a:lvl3pPr>
            <a:lvl4pPr marL="930039" indent="0">
              <a:buNone/>
              <a:defRPr sz="678"/>
            </a:lvl4pPr>
            <a:lvl5pPr marL="1240055" indent="0">
              <a:buNone/>
              <a:defRPr sz="678"/>
            </a:lvl5pPr>
            <a:lvl6pPr marL="1550068" indent="0">
              <a:buNone/>
              <a:defRPr sz="678"/>
            </a:lvl6pPr>
            <a:lvl7pPr marL="1860082" indent="0">
              <a:buNone/>
              <a:defRPr sz="678"/>
            </a:lvl7pPr>
            <a:lvl8pPr marL="2170095" indent="0">
              <a:buNone/>
              <a:defRPr sz="678"/>
            </a:lvl8pPr>
            <a:lvl9pPr marL="2480109" indent="0">
              <a:buNone/>
              <a:defRPr sz="6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5454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8227" y="507882"/>
            <a:ext cx="5246846" cy="1843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8227" y="2539394"/>
            <a:ext cx="5246846" cy="60525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8232" y="8841509"/>
            <a:ext cx="1368743" cy="5078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0A9595-01BA-4BAE-BE39-33050158DD18}" type="datetimeFigureOut">
              <a:rPr lang="en-AU" smtClean="0"/>
              <a:t>2/12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15093" y="8841509"/>
            <a:ext cx="2053114" cy="5078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96335" y="8841509"/>
            <a:ext cx="1368743" cy="5078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8C8764-9AB5-4374-B894-F6867E1A34C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1886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0027" rtl="0" eaLnBrk="1" latinLnBrk="0" hangingPunct="1">
        <a:lnSpc>
          <a:spcPct val="90000"/>
        </a:lnSpc>
        <a:spcBef>
          <a:spcPct val="0"/>
        </a:spcBef>
        <a:buNone/>
        <a:defRPr sz="298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007" indent="-155007" algn="l" defTabSz="620027" rtl="0" eaLnBrk="1" latinLnBrk="0" hangingPunct="1">
        <a:lnSpc>
          <a:spcPct val="90000"/>
        </a:lnSpc>
        <a:spcBef>
          <a:spcPts val="678"/>
        </a:spcBef>
        <a:buFont typeface="Arial" panose="020B0604020202020204" pitchFamily="34" charset="0"/>
        <a:buChar char="•"/>
        <a:defRPr sz="1899" kern="1200">
          <a:solidFill>
            <a:schemeClr val="tx1"/>
          </a:solidFill>
          <a:latin typeface="+mn-lt"/>
          <a:ea typeface="+mn-ea"/>
          <a:cs typeface="+mn-cs"/>
        </a:defRPr>
      </a:lvl1pPr>
      <a:lvl2pPr marL="465020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628" kern="1200">
          <a:solidFill>
            <a:schemeClr val="tx1"/>
          </a:solidFill>
          <a:latin typeface="+mn-lt"/>
          <a:ea typeface="+mn-ea"/>
          <a:cs typeface="+mn-cs"/>
        </a:defRPr>
      </a:lvl2pPr>
      <a:lvl3pPr marL="775034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357" kern="1200">
          <a:solidFill>
            <a:schemeClr val="tx1"/>
          </a:solidFill>
          <a:latin typeface="+mn-lt"/>
          <a:ea typeface="+mn-ea"/>
          <a:cs typeface="+mn-cs"/>
        </a:defRPr>
      </a:lvl3pPr>
      <a:lvl4pPr marL="1085047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4pPr>
      <a:lvl5pPr marL="1395062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5pPr>
      <a:lvl6pPr marL="1705075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6pPr>
      <a:lvl7pPr marL="2015090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7pPr>
      <a:lvl8pPr marL="2325102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8pPr>
      <a:lvl9pPr marL="2635116" indent="-155007" algn="l" defTabSz="620027" rtl="0" eaLnBrk="1" latinLnBrk="0" hangingPunct="1">
        <a:lnSpc>
          <a:spcPct val="90000"/>
        </a:lnSpc>
        <a:spcBef>
          <a:spcPts val="339"/>
        </a:spcBef>
        <a:buFont typeface="Arial" panose="020B0604020202020204" pitchFamily="34" charset="0"/>
        <a:buChar char="•"/>
        <a:defRPr sz="12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1pPr>
      <a:lvl2pPr marL="310013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2pPr>
      <a:lvl3pPr marL="620027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3pPr>
      <a:lvl4pPr marL="930039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4pPr>
      <a:lvl5pPr marL="1240055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5pPr>
      <a:lvl6pPr marL="1550068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6pPr>
      <a:lvl7pPr marL="1860082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7pPr>
      <a:lvl8pPr marL="2170095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8pPr>
      <a:lvl9pPr marL="2480109" algn="l" defTabSz="620027" rtl="0" eaLnBrk="1" latinLnBrk="0" hangingPunct="1">
        <a:defRPr sz="12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hyperlink" Target="https://spliceailookup.broadinstitute.or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Group 111">
            <a:extLst>
              <a:ext uri="{FF2B5EF4-FFF2-40B4-BE49-F238E27FC236}">
                <a16:creationId xmlns:a16="http://schemas.microsoft.com/office/drawing/2014/main" id="{8C1A2190-F12F-78D4-A11B-200BDAB21546}"/>
              </a:ext>
            </a:extLst>
          </p:cNvPr>
          <p:cNvGrpSpPr/>
          <p:nvPr/>
        </p:nvGrpSpPr>
        <p:grpSpPr>
          <a:xfrm>
            <a:off x="13198" y="893680"/>
            <a:ext cx="6192763" cy="8466132"/>
            <a:chOff x="518455" y="595708"/>
            <a:chExt cx="6076307" cy="8306925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C36D7AEC-CCEC-EF90-AE01-6E5F237E981D}"/>
                </a:ext>
              </a:extLst>
            </p:cNvPr>
            <p:cNvGrpSpPr/>
            <p:nvPr/>
          </p:nvGrpSpPr>
          <p:grpSpPr>
            <a:xfrm>
              <a:off x="523112" y="818111"/>
              <a:ext cx="5771664" cy="1321150"/>
              <a:chOff x="523112" y="818111"/>
              <a:chExt cx="5771664" cy="1321150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8DE6C2E7-69DE-C0E0-B0CA-E37941C9A4EA}"/>
                  </a:ext>
                </a:extLst>
              </p:cNvPr>
              <p:cNvGrpSpPr/>
              <p:nvPr/>
            </p:nvGrpSpPr>
            <p:grpSpPr>
              <a:xfrm>
                <a:off x="523112" y="884932"/>
                <a:ext cx="5730368" cy="1254329"/>
                <a:chOff x="523112" y="884932"/>
                <a:chExt cx="5730368" cy="1254329"/>
              </a:xfrm>
            </p:grpSpPr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703926BF-E4BF-80B0-54CE-87CCEB96F5A4}"/>
                    </a:ext>
                  </a:extLst>
                </p:cNvPr>
                <p:cNvGrpSpPr/>
                <p:nvPr/>
              </p:nvGrpSpPr>
              <p:grpSpPr>
                <a:xfrm>
                  <a:off x="523112" y="884932"/>
                  <a:ext cx="5730368" cy="1254329"/>
                  <a:chOff x="523112" y="491711"/>
                  <a:chExt cx="5730368" cy="1254329"/>
                </a:xfrm>
              </p:grpSpPr>
              <p:sp>
                <p:nvSpPr>
                  <p:cNvPr id="5" name="TextBox 4">
                    <a:extLst>
                      <a:ext uri="{FF2B5EF4-FFF2-40B4-BE49-F238E27FC236}">
                        <a16:creationId xmlns:a16="http://schemas.microsoft.com/office/drawing/2014/main" id="{0ED8BA4E-FC82-AA36-9868-6E4B9D434098}"/>
                      </a:ext>
                    </a:extLst>
                  </p:cNvPr>
                  <p:cNvSpPr txBox="1"/>
                  <p:nvPr/>
                </p:nvSpPr>
                <p:spPr>
                  <a:xfrm>
                    <a:off x="523112" y="491711"/>
                    <a:ext cx="873760" cy="2648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1121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.114A&gt;G</a:t>
                    </a:r>
                  </a:p>
                </p:txBody>
              </p:sp>
              <p:pic>
                <p:nvPicPr>
                  <p:cNvPr id="4" name="Picture 3">
                    <a:extLst>
                      <a:ext uri="{FF2B5EF4-FFF2-40B4-BE49-F238E27FC236}">
                        <a16:creationId xmlns:a16="http://schemas.microsoft.com/office/drawing/2014/main" id="{2199C70E-EAD2-3D13-FFF4-8D8458734F5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3296664" y="727920"/>
                    <a:ext cx="2956816" cy="1018120"/>
                  </a:xfrm>
                  <a:prstGeom prst="rect">
                    <a:avLst/>
                  </a:prstGeom>
                </p:spPr>
              </p:pic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A72B498A-1B75-9376-5612-E09288EC8E9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rcRect t="4627" r="3198"/>
                  <a:stretch/>
                </p:blipFill>
                <p:spPr>
                  <a:xfrm>
                    <a:off x="591687" y="727920"/>
                    <a:ext cx="2555374" cy="89542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FA1CC7D3-0234-A595-772B-386536F05B13}"/>
                    </a:ext>
                  </a:extLst>
                </p:cNvPr>
                <p:cNvGrpSpPr/>
                <p:nvPr/>
              </p:nvGrpSpPr>
              <p:grpSpPr>
                <a:xfrm>
                  <a:off x="3177952" y="1210000"/>
                  <a:ext cx="569560" cy="471752"/>
                  <a:chOff x="3194886" y="1184600"/>
                  <a:chExt cx="569560" cy="471752"/>
                </a:xfrm>
              </p:grpSpPr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B362AEFC-F4EC-943C-AF22-6C75652567B3}"/>
                      </a:ext>
                    </a:extLst>
                  </p:cNvPr>
                  <p:cNvSpPr txBox="1"/>
                  <p:nvPr/>
                </p:nvSpPr>
                <p:spPr>
                  <a:xfrm>
                    <a:off x="3194888" y="1184600"/>
                    <a:ext cx="569558" cy="2177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1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F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5DAD93D0-51AE-62CC-286C-05AB72755E5E}"/>
                      </a:ext>
                    </a:extLst>
                  </p:cNvPr>
                  <p:cNvSpPr txBox="1"/>
                  <p:nvPr/>
                </p:nvSpPr>
                <p:spPr>
                  <a:xfrm>
                    <a:off x="3194886" y="1438600"/>
                    <a:ext cx="569558" cy="2177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1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T</a:t>
                    </a:r>
                  </a:p>
                </p:txBody>
              </p:sp>
            </p:grpSp>
          </p:grp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8442F737-C7EE-2187-7C0C-008E12CDE012}"/>
                  </a:ext>
                </a:extLst>
              </p:cNvPr>
              <p:cNvSpPr txBox="1"/>
              <p:nvPr/>
            </p:nvSpPr>
            <p:spPr>
              <a:xfrm>
                <a:off x="3363012" y="919716"/>
                <a:ext cx="569558" cy="406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02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nor</a:t>
                </a:r>
              </a:p>
              <a:p>
                <a:pPr algn="ctr"/>
                <a:r>
                  <a:rPr lang="en-AU" sz="1020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↓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D3905C2-ACDE-1F7D-A800-978D27CB1A65}"/>
                  </a:ext>
                </a:extLst>
              </p:cNvPr>
              <p:cNvSpPr txBox="1"/>
              <p:nvPr/>
            </p:nvSpPr>
            <p:spPr>
              <a:xfrm>
                <a:off x="5595259" y="818111"/>
                <a:ext cx="699517" cy="406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02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ceptor</a:t>
                </a:r>
              </a:p>
              <a:p>
                <a:pPr algn="ctr"/>
                <a:r>
                  <a:rPr lang="en-AU" sz="1020" dirty="0">
                    <a:solidFill>
                      <a:schemeClr val="accent2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↓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6ED34BD-1452-4E61-E54C-7B5F9F3A5474}"/>
                  </a:ext>
                </a:extLst>
              </p:cNvPr>
              <p:cNvSpPr txBox="1"/>
              <p:nvPr/>
            </p:nvSpPr>
            <p:spPr>
              <a:xfrm>
                <a:off x="5614219" y="1494055"/>
                <a:ext cx="362396" cy="374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917" b="1" dirty="0">
                    <a:solidFill>
                      <a:srgbClr val="C0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↑</a:t>
                </a:r>
              </a:p>
              <a:p>
                <a:pPr algn="ctr"/>
                <a:r>
                  <a:rPr lang="en-AU" sz="917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</a:t>
                </a:r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0800E4FE-D131-288E-43BA-069C11D24643}"/>
                </a:ext>
              </a:extLst>
            </p:cNvPr>
            <p:cNvGrpSpPr/>
            <p:nvPr/>
          </p:nvGrpSpPr>
          <p:grpSpPr>
            <a:xfrm>
              <a:off x="548512" y="2161009"/>
              <a:ext cx="5704968" cy="1256926"/>
              <a:chOff x="548512" y="2161009"/>
              <a:chExt cx="5704968" cy="1256926"/>
            </a:xfrm>
          </p:grpSpPr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4A1CE44F-0F10-6B69-AA7D-AD68D5228589}"/>
                  </a:ext>
                </a:extLst>
              </p:cNvPr>
              <p:cNvGrpSpPr/>
              <p:nvPr/>
            </p:nvGrpSpPr>
            <p:grpSpPr>
              <a:xfrm>
                <a:off x="548512" y="2161009"/>
                <a:ext cx="5704968" cy="1256926"/>
                <a:chOff x="548512" y="2161009"/>
                <a:chExt cx="5704968" cy="1256926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AA683D40-ED7E-2EB2-8BA0-825B13ACB0C9}"/>
                    </a:ext>
                  </a:extLst>
                </p:cNvPr>
                <p:cNvGrpSpPr/>
                <p:nvPr/>
              </p:nvGrpSpPr>
              <p:grpSpPr>
                <a:xfrm>
                  <a:off x="548512" y="2161009"/>
                  <a:ext cx="5704968" cy="1256926"/>
                  <a:chOff x="548512" y="1982249"/>
                  <a:chExt cx="5704968" cy="1256926"/>
                </a:xfrm>
              </p:grpSpPr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6AFEC1C0-48A6-F27C-1837-467577E3606B}"/>
                      </a:ext>
                    </a:extLst>
                  </p:cNvPr>
                  <p:cNvSpPr txBox="1"/>
                  <p:nvPr/>
                </p:nvSpPr>
                <p:spPr>
                  <a:xfrm>
                    <a:off x="548512" y="1982249"/>
                    <a:ext cx="822960" cy="2648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1121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.325T&gt;A</a:t>
                    </a:r>
                  </a:p>
                </p:txBody>
              </p:sp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B0DB6C1A-8736-5C56-20FD-E8FDCD4D0FF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3296664" y="2202765"/>
                    <a:ext cx="2956816" cy="1036410"/>
                  </a:xfrm>
                  <a:prstGeom prst="rect">
                    <a:avLst/>
                  </a:prstGeom>
                </p:spPr>
              </p:pic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5FBC3A25-9AEC-9759-7F1A-5A6837898F0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rcRect t="4938" r="3198" b="1"/>
                  <a:stretch/>
                </p:blipFill>
                <p:spPr>
                  <a:xfrm>
                    <a:off x="591687" y="2203738"/>
                    <a:ext cx="2555374" cy="93886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45" name="Group 44">
                  <a:extLst>
                    <a:ext uri="{FF2B5EF4-FFF2-40B4-BE49-F238E27FC236}">
                      <a16:creationId xmlns:a16="http://schemas.microsoft.com/office/drawing/2014/main" id="{1892C7CD-A1D0-54F8-7D61-13E9233B9714}"/>
                    </a:ext>
                  </a:extLst>
                </p:cNvPr>
                <p:cNvGrpSpPr/>
                <p:nvPr/>
              </p:nvGrpSpPr>
              <p:grpSpPr>
                <a:xfrm>
                  <a:off x="3177950" y="2471533"/>
                  <a:ext cx="569560" cy="471752"/>
                  <a:chOff x="3194886" y="1184600"/>
                  <a:chExt cx="569560" cy="471752"/>
                </a:xfrm>
              </p:grpSpPr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76D65804-C0B6-906B-000F-61B65065C792}"/>
                      </a:ext>
                    </a:extLst>
                  </p:cNvPr>
                  <p:cNvSpPr txBox="1"/>
                  <p:nvPr/>
                </p:nvSpPr>
                <p:spPr>
                  <a:xfrm>
                    <a:off x="3194888" y="1184600"/>
                    <a:ext cx="569558" cy="2177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1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F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F417B37A-26A8-024F-B934-57C874F858A0}"/>
                      </a:ext>
                    </a:extLst>
                  </p:cNvPr>
                  <p:cNvSpPr txBox="1"/>
                  <p:nvPr/>
                </p:nvSpPr>
                <p:spPr>
                  <a:xfrm>
                    <a:off x="3194886" y="1438600"/>
                    <a:ext cx="569558" cy="2177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1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T</a:t>
                    </a:r>
                  </a:p>
                </p:txBody>
              </p:sp>
            </p:grpSp>
          </p:grp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B2FED11-449E-ACD4-99C9-35D3EE0EFD0E}"/>
                  </a:ext>
                </a:extLst>
              </p:cNvPr>
              <p:cNvSpPr txBox="1"/>
              <p:nvPr/>
            </p:nvSpPr>
            <p:spPr>
              <a:xfrm>
                <a:off x="3896253" y="2817168"/>
                <a:ext cx="362396" cy="374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917" b="1" dirty="0">
                    <a:solidFill>
                      <a:srgbClr val="C0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↑</a:t>
                </a:r>
              </a:p>
              <a:p>
                <a:pPr algn="ctr"/>
                <a:r>
                  <a:rPr lang="en-AU" sz="917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G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341305B9-A109-7622-D5A9-718D6502531D}"/>
                </a:ext>
              </a:extLst>
            </p:cNvPr>
            <p:cNvGrpSpPr/>
            <p:nvPr/>
          </p:nvGrpSpPr>
          <p:grpSpPr>
            <a:xfrm>
              <a:off x="523112" y="5080250"/>
              <a:ext cx="6071650" cy="1289575"/>
              <a:chOff x="523112" y="4762750"/>
              <a:chExt cx="6071650" cy="1289575"/>
            </a:xfrm>
          </p:grpSpPr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4F080DA0-AD2C-D4FD-CC37-37682D362C1B}"/>
                  </a:ext>
                </a:extLst>
              </p:cNvPr>
              <p:cNvGrpSpPr/>
              <p:nvPr/>
            </p:nvGrpSpPr>
            <p:grpSpPr>
              <a:xfrm>
                <a:off x="523112" y="4762750"/>
                <a:ext cx="5730368" cy="1289575"/>
                <a:chOff x="523112" y="4762750"/>
                <a:chExt cx="5730368" cy="1289575"/>
              </a:xfrm>
            </p:grpSpPr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37590216-CB6B-0DD7-0AC7-D881552EED86}"/>
                    </a:ext>
                  </a:extLst>
                </p:cNvPr>
                <p:cNvGrpSpPr/>
                <p:nvPr/>
              </p:nvGrpSpPr>
              <p:grpSpPr>
                <a:xfrm>
                  <a:off x="523112" y="4762750"/>
                  <a:ext cx="5730368" cy="1289575"/>
                  <a:chOff x="523112" y="4762750"/>
                  <a:chExt cx="5730368" cy="1289575"/>
                </a:xfrm>
              </p:grpSpPr>
              <p:grpSp>
                <p:nvGrpSpPr>
                  <p:cNvPr id="39" name="Group 38">
                    <a:extLst>
                      <a:ext uri="{FF2B5EF4-FFF2-40B4-BE49-F238E27FC236}">
                        <a16:creationId xmlns:a16="http://schemas.microsoft.com/office/drawing/2014/main" id="{A49A062C-9722-7322-DD61-2EC11E5FC4F4}"/>
                      </a:ext>
                    </a:extLst>
                  </p:cNvPr>
                  <p:cNvGrpSpPr/>
                  <p:nvPr/>
                </p:nvGrpSpPr>
                <p:grpSpPr>
                  <a:xfrm>
                    <a:off x="523112" y="4762750"/>
                    <a:ext cx="5730368" cy="1289575"/>
                    <a:chOff x="523112" y="4724650"/>
                    <a:chExt cx="5730368" cy="1289575"/>
                  </a:xfrm>
                </p:grpSpPr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BE068940-09BA-C038-7754-DE8CFB7FE27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112" y="4724650"/>
                      <a:ext cx="840740" cy="2648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AU" sz="1121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11G&gt;C</a:t>
                      </a:r>
                    </a:p>
                  </p:txBody>
                </p:sp>
                <p:pic>
                  <p:nvPicPr>
                    <p:cNvPr id="14" name="Picture 13">
                      <a:extLst>
                        <a:ext uri="{FF2B5EF4-FFF2-40B4-BE49-F238E27FC236}">
                          <a16:creationId xmlns:a16="http://schemas.microsoft.com/office/drawing/2014/main" id="{44C9DD34-AAE0-4F74-5F9A-81B87FEE321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3296664" y="4977815"/>
                      <a:ext cx="2956816" cy="103641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5" name="Picture 14">
                      <a:extLst>
                        <a:ext uri="{FF2B5EF4-FFF2-40B4-BE49-F238E27FC236}">
                          <a16:creationId xmlns:a16="http://schemas.microsoft.com/office/drawing/2014/main" id="{14E1F07E-8EDD-E7FA-20A1-91F4A585F80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rcRect r="3198"/>
                    <a:stretch/>
                  </p:blipFill>
                  <p:spPr>
                    <a:xfrm>
                      <a:off x="591687" y="4953000"/>
                      <a:ext cx="2555371" cy="938865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51" name="Group 50">
                    <a:extLst>
                      <a:ext uri="{FF2B5EF4-FFF2-40B4-BE49-F238E27FC236}">
                        <a16:creationId xmlns:a16="http://schemas.microsoft.com/office/drawing/2014/main" id="{BB28CB98-1C01-C424-10B7-22F97543DC37}"/>
                      </a:ext>
                    </a:extLst>
                  </p:cNvPr>
                  <p:cNvGrpSpPr/>
                  <p:nvPr/>
                </p:nvGrpSpPr>
                <p:grpSpPr>
                  <a:xfrm>
                    <a:off x="3186414" y="5104669"/>
                    <a:ext cx="569560" cy="471752"/>
                    <a:chOff x="3194886" y="1184600"/>
                    <a:chExt cx="569560" cy="471752"/>
                  </a:xfrm>
                </p:grpSpPr>
                <p:sp>
                  <p:nvSpPr>
                    <p:cNvPr id="52" name="TextBox 51">
                      <a:extLst>
                        <a:ext uri="{FF2B5EF4-FFF2-40B4-BE49-F238E27FC236}">
                          <a16:creationId xmlns:a16="http://schemas.microsoft.com/office/drawing/2014/main" id="{9A7B9AA6-AF17-AC7B-EDD2-D678FAA11B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8" y="1184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p:txBody>
                </p:sp>
                <p:sp>
                  <p:nvSpPr>
                    <p:cNvPr id="53" name="TextBox 52">
                      <a:extLst>
                        <a:ext uri="{FF2B5EF4-FFF2-40B4-BE49-F238E27FC236}">
                          <a16:creationId xmlns:a16="http://schemas.microsoft.com/office/drawing/2014/main" id="{A9AC6CA4-9780-5EF8-D7A4-E6EFC471C55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6" y="1438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</a:t>
                      </a:r>
                    </a:p>
                  </p:txBody>
                </p:sp>
              </p:grpSp>
            </p:grp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9B387103-44E4-2A3A-4983-3511799C5A1E}"/>
                    </a:ext>
                  </a:extLst>
                </p:cNvPr>
                <p:cNvSpPr txBox="1"/>
                <p:nvPr/>
              </p:nvSpPr>
              <p:spPr>
                <a:xfrm>
                  <a:off x="5341205" y="5373335"/>
                  <a:ext cx="362396" cy="374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↑</a:t>
                  </a:r>
                </a:p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G</a:t>
                  </a:r>
                </a:p>
              </p:txBody>
            </p:sp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8933BF2A-F5EF-4014-A6A9-C47D31B08EE7}"/>
                  </a:ext>
                </a:extLst>
              </p:cNvPr>
              <p:cNvGrpSpPr/>
              <p:nvPr/>
            </p:nvGrpSpPr>
            <p:grpSpPr>
              <a:xfrm>
                <a:off x="5949329" y="5427865"/>
                <a:ext cx="645433" cy="394850"/>
                <a:chOff x="5935476" y="4090902"/>
                <a:chExt cx="645433" cy="394850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86B605EA-E8F6-F0AF-1E7D-70C82848A238}"/>
                    </a:ext>
                  </a:extLst>
                </p:cNvPr>
                <p:cNvSpPr txBox="1"/>
                <p:nvPr/>
              </p:nvSpPr>
              <p:spPr>
                <a:xfrm>
                  <a:off x="5935476" y="4142581"/>
                  <a:ext cx="645433" cy="3431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815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ryptic acceptor</a:t>
                  </a:r>
                </a:p>
              </p:txBody>
            </p:sp>
            <p:cxnSp>
              <p:nvCxnSpPr>
                <p:cNvPr id="87" name="Straight Arrow Connector 86">
                  <a:extLst>
                    <a:ext uri="{FF2B5EF4-FFF2-40B4-BE49-F238E27FC236}">
                      <a16:creationId xmlns:a16="http://schemas.microsoft.com/office/drawing/2014/main" id="{74A3C830-C16D-6460-6EBA-7591DEC9CA9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955834" y="4090902"/>
                  <a:ext cx="62343" cy="120949"/>
                </a:xfrm>
                <a:prstGeom prst="straightConnector1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  <a:headEnd type="none" w="med" len="med"/>
                  <a:tailEnd type="triangle" w="med" len="med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A3B4E941-F9F1-2F54-80F2-D145D22F9B74}"/>
                </a:ext>
              </a:extLst>
            </p:cNvPr>
            <p:cNvGrpSpPr/>
            <p:nvPr/>
          </p:nvGrpSpPr>
          <p:grpSpPr>
            <a:xfrm>
              <a:off x="548512" y="6423469"/>
              <a:ext cx="6039324" cy="1237203"/>
              <a:chOff x="548512" y="6105969"/>
              <a:chExt cx="6039324" cy="1237203"/>
            </a:xfrm>
          </p:grpSpPr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A211C0B4-90F6-C9C9-9840-3BC7A1BC6CDB}"/>
                  </a:ext>
                </a:extLst>
              </p:cNvPr>
              <p:cNvGrpSpPr/>
              <p:nvPr/>
            </p:nvGrpSpPr>
            <p:grpSpPr>
              <a:xfrm>
                <a:off x="548512" y="6105969"/>
                <a:ext cx="5704968" cy="1237203"/>
                <a:chOff x="548512" y="6105969"/>
                <a:chExt cx="5704968" cy="1237203"/>
              </a:xfrm>
            </p:grpSpPr>
            <p:grpSp>
              <p:nvGrpSpPr>
                <p:cNvPr id="64" name="Group 63">
                  <a:extLst>
                    <a:ext uri="{FF2B5EF4-FFF2-40B4-BE49-F238E27FC236}">
                      <a16:creationId xmlns:a16="http://schemas.microsoft.com/office/drawing/2014/main" id="{A6A378BF-B063-ED88-7D40-4D41673A9E61}"/>
                    </a:ext>
                  </a:extLst>
                </p:cNvPr>
                <p:cNvGrpSpPr/>
                <p:nvPr/>
              </p:nvGrpSpPr>
              <p:grpSpPr>
                <a:xfrm>
                  <a:off x="548512" y="6105969"/>
                  <a:ext cx="5704968" cy="1237203"/>
                  <a:chOff x="548512" y="6105969"/>
                  <a:chExt cx="5704968" cy="1237203"/>
                </a:xfrm>
              </p:grpSpPr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C17911D6-8676-E78F-C0AC-3D06B283CD38}"/>
                      </a:ext>
                    </a:extLst>
                  </p:cNvPr>
                  <p:cNvGrpSpPr/>
                  <p:nvPr/>
                </p:nvGrpSpPr>
                <p:grpSpPr>
                  <a:xfrm>
                    <a:off x="548512" y="6105969"/>
                    <a:ext cx="5704968" cy="1237203"/>
                    <a:chOff x="548512" y="5997877"/>
                    <a:chExt cx="5704968" cy="1237203"/>
                  </a:xfrm>
                </p:grpSpPr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FBEAEEDA-1E30-4F61-8B63-A9ADA17A11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8512" y="5997877"/>
                      <a:ext cx="828040" cy="2648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AU" sz="1121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37G&gt;T</a:t>
                      </a:r>
                    </a:p>
                  </p:txBody>
                </p:sp>
                <p:pic>
                  <p:nvPicPr>
                    <p:cNvPr id="28" name="Picture 27">
                      <a:extLst>
                        <a:ext uri="{FF2B5EF4-FFF2-40B4-BE49-F238E27FC236}">
                          <a16:creationId xmlns:a16="http://schemas.microsoft.com/office/drawing/2014/main" id="{15F68DC7-704D-20AE-0F6D-B59057B996A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3296664" y="6198670"/>
                      <a:ext cx="2956816" cy="103641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" name="Picture 17">
                      <a:extLst>
                        <a:ext uri="{FF2B5EF4-FFF2-40B4-BE49-F238E27FC236}">
                          <a16:creationId xmlns:a16="http://schemas.microsoft.com/office/drawing/2014/main" id="{08AF6D93-2EDA-22ED-6A23-DD110661682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rcRect r="3198"/>
                    <a:stretch/>
                  </p:blipFill>
                  <p:spPr>
                    <a:xfrm>
                      <a:off x="591687" y="6198670"/>
                      <a:ext cx="2555371" cy="938865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54" name="Group 53">
                    <a:extLst>
                      <a:ext uri="{FF2B5EF4-FFF2-40B4-BE49-F238E27FC236}">
                        <a16:creationId xmlns:a16="http://schemas.microsoft.com/office/drawing/2014/main" id="{54BA741F-CFEC-E57A-B9E3-2888406771C7}"/>
                      </a:ext>
                    </a:extLst>
                  </p:cNvPr>
                  <p:cNvGrpSpPr/>
                  <p:nvPr/>
                </p:nvGrpSpPr>
                <p:grpSpPr>
                  <a:xfrm>
                    <a:off x="3186414" y="6417003"/>
                    <a:ext cx="569560" cy="471752"/>
                    <a:chOff x="3194886" y="1184600"/>
                    <a:chExt cx="569560" cy="471752"/>
                  </a:xfrm>
                </p:grpSpPr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D93E091A-2E1C-DDC4-E2FB-8571C989FDF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8" y="1184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p:txBody>
                </p:sp>
                <p:sp>
                  <p:nvSpPr>
                    <p:cNvPr id="56" name="TextBox 55">
                      <a:extLst>
                        <a:ext uri="{FF2B5EF4-FFF2-40B4-BE49-F238E27FC236}">
                          <a16:creationId xmlns:a16="http://schemas.microsoft.com/office/drawing/2014/main" id="{9164FA36-FD25-9EAD-6CBF-396389215C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6" y="1438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</a:t>
                      </a:r>
                    </a:p>
                  </p:txBody>
                </p:sp>
              </p:grpSp>
            </p:grp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F15C7AF6-4CCA-BA68-DB9E-FE2F99E91D95}"/>
                    </a:ext>
                  </a:extLst>
                </p:cNvPr>
                <p:cNvSpPr txBox="1"/>
                <p:nvPr/>
              </p:nvSpPr>
              <p:spPr>
                <a:xfrm>
                  <a:off x="4788384" y="6675658"/>
                  <a:ext cx="362396" cy="374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↑</a:t>
                  </a:r>
                </a:p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G</a:t>
                  </a:r>
                </a:p>
              </p:txBody>
            </p:sp>
          </p:grp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035AC845-6751-F886-2678-FA0D301459F0}"/>
                  </a:ext>
                </a:extLst>
              </p:cNvPr>
              <p:cNvGrpSpPr/>
              <p:nvPr/>
            </p:nvGrpSpPr>
            <p:grpSpPr>
              <a:xfrm>
                <a:off x="5942403" y="6730189"/>
                <a:ext cx="645433" cy="394850"/>
                <a:chOff x="5935476" y="4090902"/>
                <a:chExt cx="645433" cy="394850"/>
              </a:xfrm>
            </p:grpSpPr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FA9D0D4D-095A-46F2-C601-5B25ACC1B62F}"/>
                    </a:ext>
                  </a:extLst>
                </p:cNvPr>
                <p:cNvSpPr txBox="1"/>
                <p:nvPr/>
              </p:nvSpPr>
              <p:spPr>
                <a:xfrm>
                  <a:off x="5935476" y="4142581"/>
                  <a:ext cx="645433" cy="3431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815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ryptic acceptor</a:t>
                  </a:r>
                </a:p>
              </p:txBody>
            </p:sp>
            <p:cxnSp>
              <p:nvCxnSpPr>
                <p:cNvPr id="90" name="Straight Arrow Connector 89">
                  <a:extLst>
                    <a:ext uri="{FF2B5EF4-FFF2-40B4-BE49-F238E27FC236}">
                      <a16:creationId xmlns:a16="http://schemas.microsoft.com/office/drawing/2014/main" id="{0E34D85C-CBF2-7F61-75CE-C374AEA5D3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955834" y="4090902"/>
                  <a:ext cx="62343" cy="120949"/>
                </a:xfrm>
                <a:prstGeom prst="straightConnector1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  <a:headEnd type="none" w="med" len="med"/>
                  <a:tailEnd type="triangle" w="med" len="med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E3895DC6-242D-3A60-EB38-D0263FAFFA2D}"/>
                </a:ext>
              </a:extLst>
            </p:cNvPr>
            <p:cNvGrpSpPr/>
            <p:nvPr/>
          </p:nvGrpSpPr>
          <p:grpSpPr>
            <a:xfrm>
              <a:off x="518455" y="7707237"/>
              <a:ext cx="6076307" cy="1195396"/>
              <a:chOff x="518455" y="7389737"/>
              <a:chExt cx="6076307" cy="1195396"/>
            </a:xfrm>
          </p:grpSpPr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C3638C79-C260-82D9-6ED5-D31B1B52C06A}"/>
                  </a:ext>
                </a:extLst>
              </p:cNvPr>
              <p:cNvGrpSpPr/>
              <p:nvPr/>
            </p:nvGrpSpPr>
            <p:grpSpPr>
              <a:xfrm>
                <a:off x="518455" y="7389737"/>
                <a:ext cx="5735025" cy="1195396"/>
                <a:chOff x="518455" y="7389737"/>
                <a:chExt cx="5735025" cy="1195396"/>
              </a:xfrm>
            </p:grpSpPr>
            <p:grpSp>
              <p:nvGrpSpPr>
                <p:cNvPr id="65" name="Group 64">
                  <a:extLst>
                    <a:ext uri="{FF2B5EF4-FFF2-40B4-BE49-F238E27FC236}">
                      <a16:creationId xmlns:a16="http://schemas.microsoft.com/office/drawing/2014/main" id="{9D663108-A81B-B050-BFAA-F9DD6D845D79}"/>
                    </a:ext>
                  </a:extLst>
                </p:cNvPr>
                <p:cNvGrpSpPr/>
                <p:nvPr/>
              </p:nvGrpSpPr>
              <p:grpSpPr>
                <a:xfrm>
                  <a:off x="518455" y="7389737"/>
                  <a:ext cx="5735025" cy="1195396"/>
                  <a:chOff x="518455" y="7389737"/>
                  <a:chExt cx="5735025" cy="1195396"/>
                </a:xfrm>
              </p:grpSpPr>
              <p:grpSp>
                <p:nvGrpSpPr>
                  <p:cNvPr id="41" name="Group 40">
                    <a:extLst>
                      <a:ext uri="{FF2B5EF4-FFF2-40B4-BE49-F238E27FC236}">
                        <a16:creationId xmlns:a16="http://schemas.microsoft.com/office/drawing/2014/main" id="{127D3E2F-446E-55EF-8DE4-4E1F3C4B3B0D}"/>
                      </a:ext>
                    </a:extLst>
                  </p:cNvPr>
                  <p:cNvGrpSpPr/>
                  <p:nvPr/>
                </p:nvGrpSpPr>
                <p:grpSpPr>
                  <a:xfrm>
                    <a:off x="518455" y="7389737"/>
                    <a:ext cx="5735025" cy="1195396"/>
                    <a:chOff x="518455" y="7364337"/>
                    <a:chExt cx="5735025" cy="1195396"/>
                  </a:xfrm>
                </p:grpSpPr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887241AD-B453-1F2B-75B6-EBB45981F41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8455" y="7364337"/>
                      <a:ext cx="832273" cy="25983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AU" sz="1121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37G&gt;C</a:t>
                      </a:r>
                    </a:p>
                  </p:txBody>
                </p:sp>
                <p:pic>
                  <p:nvPicPr>
                    <p:cNvPr id="29" name="Picture 28">
                      <a:extLst>
                        <a:ext uri="{FF2B5EF4-FFF2-40B4-BE49-F238E27FC236}">
                          <a16:creationId xmlns:a16="http://schemas.microsoft.com/office/drawing/2014/main" id="{CC5F0300-FD8A-FF06-6FD4-A2E510AF3AE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tretch>
                      <a:fillRect/>
                    </a:stretch>
                  </p:blipFill>
                  <p:spPr>
                    <a:xfrm>
                      <a:off x="3296664" y="7529420"/>
                      <a:ext cx="2956816" cy="103031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1" name="Picture 20">
                      <a:extLst>
                        <a:ext uri="{FF2B5EF4-FFF2-40B4-BE49-F238E27FC236}">
                          <a16:creationId xmlns:a16="http://schemas.microsoft.com/office/drawing/2014/main" id="{1D8FCA6A-03B4-9DC0-9936-78B93193FB6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rcRect t="3604" r="3198" b="8395"/>
                    <a:stretch/>
                  </p:blipFill>
                  <p:spPr>
                    <a:xfrm>
                      <a:off x="604521" y="7567921"/>
                      <a:ext cx="2555372" cy="938865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57" name="Group 56">
                    <a:extLst>
                      <a:ext uri="{FF2B5EF4-FFF2-40B4-BE49-F238E27FC236}">
                        <a16:creationId xmlns:a16="http://schemas.microsoft.com/office/drawing/2014/main" id="{E003677C-9E72-B05E-4995-35FBD3376FCC}"/>
                      </a:ext>
                    </a:extLst>
                  </p:cNvPr>
                  <p:cNvGrpSpPr/>
                  <p:nvPr/>
                </p:nvGrpSpPr>
                <p:grpSpPr>
                  <a:xfrm>
                    <a:off x="3186413" y="7670072"/>
                    <a:ext cx="569560" cy="471752"/>
                    <a:chOff x="3194886" y="1184600"/>
                    <a:chExt cx="569560" cy="471752"/>
                  </a:xfrm>
                </p:grpSpPr>
                <p:sp>
                  <p:nvSpPr>
                    <p:cNvPr id="58" name="TextBox 57">
                      <a:extLst>
                        <a:ext uri="{FF2B5EF4-FFF2-40B4-BE49-F238E27FC236}">
                          <a16:creationId xmlns:a16="http://schemas.microsoft.com/office/drawing/2014/main" id="{677F9AB0-5426-8CB2-7A96-C36DC3DF117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8" y="1184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p:txBody>
                </p:sp>
                <p:sp>
                  <p:nvSpPr>
                    <p:cNvPr id="59" name="TextBox 58">
                      <a:extLst>
                        <a:ext uri="{FF2B5EF4-FFF2-40B4-BE49-F238E27FC236}">
                          <a16:creationId xmlns:a16="http://schemas.microsoft.com/office/drawing/2014/main" id="{4575833C-6930-BA5B-6B49-C0DFFDECB4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4886" y="1438600"/>
                      <a:ext cx="569558" cy="21775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81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</a:t>
                      </a:r>
                    </a:p>
                  </p:txBody>
                </p:sp>
              </p:grpSp>
            </p:grp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29334DE6-1CBA-CDB2-1A9E-38D0615009CF}"/>
                    </a:ext>
                  </a:extLst>
                </p:cNvPr>
                <p:cNvSpPr txBox="1"/>
                <p:nvPr/>
              </p:nvSpPr>
              <p:spPr>
                <a:xfrm>
                  <a:off x="4802238" y="7929494"/>
                  <a:ext cx="362396" cy="374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↑</a:t>
                  </a:r>
                </a:p>
                <a:p>
                  <a:pPr algn="ctr"/>
                  <a:r>
                    <a:rPr lang="en-AU" sz="917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G</a:t>
                  </a:r>
                </a:p>
              </p:txBody>
            </p:sp>
          </p:grp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169CFBA1-DAB0-EDAE-98A3-058C00FD697E}"/>
                  </a:ext>
                </a:extLst>
              </p:cNvPr>
              <p:cNvGrpSpPr/>
              <p:nvPr/>
            </p:nvGrpSpPr>
            <p:grpSpPr>
              <a:xfrm>
                <a:off x="5949329" y="7977096"/>
                <a:ext cx="645433" cy="394850"/>
                <a:chOff x="5935476" y="4090902"/>
                <a:chExt cx="645433" cy="394850"/>
              </a:xfrm>
            </p:grpSpPr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351C1E8E-7FDB-E3BF-2CAF-AA12EBB0E769}"/>
                    </a:ext>
                  </a:extLst>
                </p:cNvPr>
                <p:cNvSpPr txBox="1"/>
                <p:nvPr/>
              </p:nvSpPr>
              <p:spPr>
                <a:xfrm>
                  <a:off x="5935476" y="4142581"/>
                  <a:ext cx="645433" cy="3431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815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ryptic acceptor</a:t>
                  </a:r>
                </a:p>
              </p:txBody>
            </p:sp>
            <p:cxnSp>
              <p:nvCxnSpPr>
                <p:cNvPr id="93" name="Straight Arrow Connector 92">
                  <a:extLst>
                    <a:ext uri="{FF2B5EF4-FFF2-40B4-BE49-F238E27FC236}">
                      <a16:creationId xmlns:a16="http://schemas.microsoft.com/office/drawing/2014/main" id="{261C9E3F-7BE1-C9D7-BA22-C3A8309ACEB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955834" y="4090902"/>
                  <a:ext cx="62343" cy="120949"/>
                </a:xfrm>
                <a:prstGeom prst="straightConnector1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  <a:headEnd type="none" w="med" len="med"/>
                  <a:tailEnd type="triangle" w="med" len="med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45B9BEC8-E1CC-E28F-4A0D-8310113FCBB8}"/>
                </a:ext>
              </a:extLst>
            </p:cNvPr>
            <p:cNvGrpSpPr/>
            <p:nvPr/>
          </p:nvGrpSpPr>
          <p:grpSpPr>
            <a:xfrm>
              <a:off x="518455" y="3709483"/>
              <a:ext cx="6069381" cy="1337633"/>
              <a:chOff x="518455" y="3709483"/>
              <a:chExt cx="6069381" cy="1337633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607FBB99-E5A2-F3F5-605B-525E305BEB66}"/>
                  </a:ext>
                </a:extLst>
              </p:cNvPr>
              <p:cNvGrpSpPr/>
              <p:nvPr/>
            </p:nvGrpSpPr>
            <p:grpSpPr>
              <a:xfrm>
                <a:off x="518455" y="3782964"/>
                <a:ext cx="6069381" cy="1264152"/>
                <a:chOff x="518455" y="3465464"/>
                <a:chExt cx="6069381" cy="1264152"/>
              </a:xfrm>
            </p:grpSpPr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CB8C9EBE-CEC3-85E0-BCC0-644826DA2792}"/>
                    </a:ext>
                  </a:extLst>
                </p:cNvPr>
                <p:cNvGrpSpPr/>
                <p:nvPr/>
              </p:nvGrpSpPr>
              <p:grpSpPr>
                <a:xfrm>
                  <a:off x="518455" y="3465464"/>
                  <a:ext cx="5736718" cy="1264152"/>
                  <a:chOff x="518455" y="3465464"/>
                  <a:chExt cx="5736718" cy="1264152"/>
                </a:xfrm>
              </p:grpSpPr>
              <p:grpSp>
                <p:nvGrpSpPr>
                  <p:cNvPr id="62" name="Group 61">
                    <a:extLst>
                      <a:ext uri="{FF2B5EF4-FFF2-40B4-BE49-F238E27FC236}">
                        <a16:creationId xmlns:a16="http://schemas.microsoft.com/office/drawing/2014/main" id="{D025C2C6-3E82-41BD-3ADD-D6392D4AD646}"/>
                      </a:ext>
                    </a:extLst>
                  </p:cNvPr>
                  <p:cNvGrpSpPr/>
                  <p:nvPr/>
                </p:nvGrpSpPr>
                <p:grpSpPr>
                  <a:xfrm>
                    <a:off x="518455" y="3465464"/>
                    <a:ext cx="5736718" cy="1264152"/>
                    <a:chOff x="518455" y="3465464"/>
                    <a:chExt cx="5736718" cy="1264152"/>
                  </a:xfrm>
                </p:grpSpPr>
                <p:grpSp>
                  <p:nvGrpSpPr>
                    <p:cNvPr id="38" name="Group 37">
                      <a:extLst>
                        <a:ext uri="{FF2B5EF4-FFF2-40B4-BE49-F238E27FC236}">
                          <a16:creationId xmlns:a16="http://schemas.microsoft.com/office/drawing/2014/main" id="{A72B5549-D549-CB16-DBE7-1CD89B2AB2E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18455" y="3465464"/>
                      <a:ext cx="5736718" cy="1264152"/>
                      <a:chOff x="516762" y="3452053"/>
                      <a:chExt cx="5736718" cy="1264152"/>
                    </a:xfrm>
                  </p:grpSpPr>
                  <p:sp>
                    <p:nvSpPr>
                      <p:cNvPr id="10" name="TextBox 9">
                        <a:extLst>
                          <a:ext uri="{FF2B5EF4-FFF2-40B4-BE49-F238E27FC236}">
                            <a16:creationId xmlns:a16="http://schemas.microsoft.com/office/drawing/2014/main" id="{7FC0F15C-0DB8-DEB9-0032-3B31B1248F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16762" y="3452053"/>
                        <a:ext cx="835660" cy="25983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AU" sz="1121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.784G&gt;A</a:t>
                        </a:r>
                      </a:p>
                    </p:txBody>
                  </p:sp>
                  <p:pic>
                    <p:nvPicPr>
                      <p:cNvPr id="11" name="Picture 10">
                        <a:extLst>
                          <a:ext uri="{FF2B5EF4-FFF2-40B4-BE49-F238E27FC236}">
                            <a16:creationId xmlns:a16="http://schemas.microsoft.com/office/drawing/2014/main" id="{461137A7-7D63-DA44-B1BC-261D9C36B1DC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296664" y="3679795"/>
                        <a:ext cx="2956816" cy="103641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2" name="Picture 11">
                        <a:extLst>
                          <a:ext uri="{FF2B5EF4-FFF2-40B4-BE49-F238E27FC236}">
                            <a16:creationId xmlns:a16="http://schemas.microsoft.com/office/drawing/2014/main" id="{424B27C1-282B-9A8D-A261-C1E8942BA63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3"/>
                      <a:srcRect r="3198"/>
                      <a:stretch/>
                    </p:blipFill>
                    <p:spPr>
                      <a:xfrm>
                        <a:off x="592496" y="3679795"/>
                        <a:ext cx="2555371" cy="938865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48" name="Group 47">
                      <a:extLst>
                        <a:ext uri="{FF2B5EF4-FFF2-40B4-BE49-F238E27FC236}">
                          <a16:creationId xmlns:a16="http://schemas.microsoft.com/office/drawing/2014/main" id="{62827651-69B9-2551-FBC1-46B0103489D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77950" y="3792334"/>
                      <a:ext cx="569560" cy="471752"/>
                      <a:chOff x="3194886" y="1184600"/>
                      <a:chExt cx="569560" cy="471752"/>
                    </a:xfrm>
                  </p:grpSpPr>
                  <p:sp>
                    <p:nvSpPr>
                      <p:cNvPr id="49" name="TextBox 48">
                        <a:extLst>
                          <a:ext uri="{FF2B5EF4-FFF2-40B4-BE49-F238E27FC236}">
                            <a16:creationId xmlns:a16="http://schemas.microsoft.com/office/drawing/2014/main" id="{94B57910-1372-7AC5-7E7F-5C4DF861AAA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94888" y="1184600"/>
                        <a:ext cx="569558" cy="2177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AU" sz="81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F</a:t>
                        </a:r>
                      </a:p>
                    </p:txBody>
                  </p:sp>
                  <p:sp>
                    <p:nvSpPr>
                      <p:cNvPr id="50" name="TextBox 49">
                        <a:extLst>
                          <a:ext uri="{FF2B5EF4-FFF2-40B4-BE49-F238E27FC236}">
                            <a16:creationId xmlns:a16="http://schemas.microsoft.com/office/drawing/2014/main" id="{FE58993D-9BFA-ED52-9A4D-DA9F6875CC7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94886" y="1438600"/>
                        <a:ext cx="569558" cy="2177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AU" sz="81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LT</a:t>
                        </a:r>
                      </a:p>
                    </p:txBody>
                  </p:sp>
                </p:grpSp>
              </p:grp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01B3457D-67E2-4EAC-A4A9-C0DF342F1383}"/>
                      </a:ext>
                    </a:extLst>
                  </p:cNvPr>
                  <p:cNvSpPr txBox="1"/>
                  <p:nvPr/>
                </p:nvSpPr>
                <p:spPr>
                  <a:xfrm>
                    <a:off x="5682005" y="4057154"/>
                    <a:ext cx="362396" cy="374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917" b="1" dirty="0">
                        <a:solidFill>
                          <a:srgbClr val="C00000"/>
                        </a:solidFill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↑</a:t>
                    </a:r>
                  </a:p>
                  <a:p>
                    <a:pPr algn="ctr"/>
                    <a:r>
                      <a:rPr lang="en-AU" sz="917" b="1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G</a:t>
                    </a:r>
                  </a:p>
                </p:txBody>
              </p:sp>
            </p:grpSp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CF126873-FE3D-D891-D03A-6C06A85E05C1}"/>
                    </a:ext>
                  </a:extLst>
                </p:cNvPr>
                <p:cNvGrpSpPr/>
                <p:nvPr/>
              </p:nvGrpSpPr>
              <p:grpSpPr>
                <a:xfrm>
                  <a:off x="5942403" y="4111683"/>
                  <a:ext cx="645433" cy="394850"/>
                  <a:chOff x="5935476" y="4090902"/>
                  <a:chExt cx="645433" cy="394850"/>
                </a:xfrm>
              </p:grpSpPr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6827B736-771A-4B3B-F9F1-9B12807B01E0}"/>
                      </a:ext>
                    </a:extLst>
                  </p:cNvPr>
                  <p:cNvSpPr txBox="1"/>
                  <p:nvPr/>
                </p:nvSpPr>
                <p:spPr>
                  <a:xfrm>
                    <a:off x="5935476" y="4142581"/>
                    <a:ext cx="645433" cy="3431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815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ryptic acceptor</a:t>
                    </a:r>
                  </a:p>
                </p:txBody>
              </p:sp>
              <p:cxnSp>
                <p:nvCxnSpPr>
                  <p:cNvPr id="82" name="Straight Arrow Connector 81">
                    <a:extLst>
                      <a:ext uri="{FF2B5EF4-FFF2-40B4-BE49-F238E27FC236}">
                        <a16:creationId xmlns:a16="http://schemas.microsoft.com/office/drawing/2014/main" id="{1AFFD702-539D-21CF-8BF3-057080DCBB3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5955834" y="4090902"/>
                    <a:ext cx="62343" cy="120949"/>
                  </a:xfrm>
                  <a:prstGeom prst="straightConnector1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  <a:headEnd type="none" w="med" len="med"/>
                    <a:tailEnd type="triangle" w="med" len="med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DC0B292D-43D6-4484-77A0-A94238DDDC9C}"/>
                  </a:ext>
                </a:extLst>
              </p:cNvPr>
              <p:cNvSpPr txBox="1"/>
              <p:nvPr/>
            </p:nvSpPr>
            <p:spPr>
              <a:xfrm>
                <a:off x="3379948" y="3819555"/>
                <a:ext cx="569558" cy="406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02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nor</a:t>
                </a:r>
              </a:p>
              <a:p>
                <a:pPr algn="ctr"/>
                <a:r>
                  <a:rPr lang="en-AU" sz="1020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↓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AACF07EF-6696-169E-83F8-05A28000C4C4}"/>
                  </a:ext>
                </a:extLst>
              </p:cNvPr>
              <p:cNvSpPr txBox="1"/>
              <p:nvPr/>
            </p:nvSpPr>
            <p:spPr>
              <a:xfrm>
                <a:off x="5552925" y="3709483"/>
                <a:ext cx="699517" cy="406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02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ceptor</a:t>
                </a:r>
              </a:p>
              <a:p>
                <a:pPr algn="ctr"/>
                <a:r>
                  <a:rPr lang="en-AU" sz="1020" dirty="0">
                    <a:solidFill>
                      <a:schemeClr val="accent2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↓</a:t>
                </a:r>
              </a:p>
            </p:txBody>
          </p: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503FED03-56E2-A278-242C-58A13918D8C2}"/>
                </a:ext>
              </a:extLst>
            </p:cNvPr>
            <p:cNvGrpSpPr/>
            <p:nvPr/>
          </p:nvGrpSpPr>
          <p:grpSpPr>
            <a:xfrm>
              <a:off x="531154" y="595708"/>
              <a:ext cx="5868000" cy="264816"/>
              <a:chOff x="531154" y="621108"/>
              <a:chExt cx="5868000" cy="264816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DC6FD9D-AD3D-3188-AA52-888EB4E2D96B}"/>
                  </a:ext>
                </a:extLst>
              </p:cNvPr>
              <p:cNvSpPr txBox="1"/>
              <p:nvPr/>
            </p:nvSpPr>
            <p:spPr>
              <a:xfrm>
                <a:off x="2966955" y="621108"/>
                <a:ext cx="1065396" cy="264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12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ON 4</a:t>
                </a:r>
              </a:p>
            </p:txBody>
          </p: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A4B38FA7-40B4-5E57-509E-04F48E7CDDEB}"/>
                  </a:ext>
                </a:extLst>
              </p:cNvPr>
              <p:cNvCxnSpPr/>
              <p:nvPr/>
            </p:nvCxnSpPr>
            <p:spPr>
              <a:xfrm>
                <a:off x="531154" y="866213"/>
                <a:ext cx="5868000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41DF2F7E-407A-9CB5-81F3-A7E850C8EA9B}"/>
                </a:ext>
              </a:extLst>
            </p:cNvPr>
            <p:cNvGrpSpPr/>
            <p:nvPr/>
          </p:nvGrpSpPr>
          <p:grpSpPr>
            <a:xfrm>
              <a:off x="531154" y="3492708"/>
              <a:ext cx="5868000" cy="264816"/>
              <a:chOff x="531154" y="3505408"/>
              <a:chExt cx="5868000" cy="264816"/>
            </a:xfrm>
          </p:grpSpPr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4546E5AB-17FD-24C6-0F5B-D314385F0FF2}"/>
                  </a:ext>
                </a:extLst>
              </p:cNvPr>
              <p:cNvSpPr txBox="1"/>
              <p:nvPr/>
            </p:nvSpPr>
            <p:spPr>
              <a:xfrm>
                <a:off x="2966956" y="3505408"/>
                <a:ext cx="1065396" cy="264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12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ON 8</a:t>
                </a:r>
              </a:p>
            </p:txBody>
          </p: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B98FA2DC-8F8D-A6FB-4A3D-748AABFAA59C}"/>
                  </a:ext>
                </a:extLst>
              </p:cNvPr>
              <p:cNvCxnSpPr/>
              <p:nvPr/>
            </p:nvCxnSpPr>
            <p:spPr>
              <a:xfrm>
                <a:off x="531154" y="3749113"/>
                <a:ext cx="5868000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Rectangle 1"/>
          <p:cNvSpPr/>
          <p:nvPr/>
        </p:nvSpPr>
        <p:spPr>
          <a:xfrm>
            <a:off x="-6116" y="48933"/>
            <a:ext cx="604003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ants predicted to induce gain of donor/acceptor sites with weaker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iceAI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ternate scores than the native splice sites and had no observed splicing impact in the assay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reenshot of predictions from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iceAI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ookup (</a:t>
            </a:r>
            <a:r>
              <a:rPr lang="en-US" sz="1100" u="sng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14"/>
              </a:rPr>
              <a:t>https://spliceailookup.broadinstitute.org/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iceAI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visual (PMID: 36765386) for the six false positive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an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2185" y="9341945"/>
            <a:ext cx="287287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AG = Acceptor gain, DG = Donor gain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557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</TotalTime>
  <Words>117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ffodil Canson</dc:creator>
  <cp:lastModifiedBy>Cristina Fortuno</cp:lastModifiedBy>
  <cp:revision>10</cp:revision>
  <dcterms:created xsi:type="dcterms:W3CDTF">2024-10-02T02:26:01Z</dcterms:created>
  <dcterms:modified xsi:type="dcterms:W3CDTF">2024-12-02T02:34:34Z</dcterms:modified>
</cp:coreProperties>
</file>